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9" d="100"/>
          <a:sy n="109" d="100"/>
        </p:scale>
        <p:origin x="1596" y="1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F0A24-8514-4CF0-A281-358CB7EC8E5B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8E81A-409C-41F1-9720-F32CE99B2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04249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F0A24-8514-4CF0-A281-358CB7EC8E5B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8E81A-409C-41F1-9720-F32CE99B2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75158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F0A24-8514-4CF0-A281-358CB7EC8E5B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8E81A-409C-41F1-9720-F32CE99B2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19267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F0A24-8514-4CF0-A281-358CB7EC8E5B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8E81A-409C-41F1-9720-F32CE99B2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89739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F0A24-8514-4CF0-A281-358CB7EC8E5B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8E81A-409C-41F1-9720-F32CE99B2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7370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F0A24-8514-4CF0-A281-358CB7EC8E5B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8E81A-409C-41F1-9720-F32CE99B2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48423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F0A24-8514-4CF0-A281-358CB7EC8E5B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8E81A-409C-41F1-9720-F32CE99B2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57810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F0A24-8514-4CF0-A281-358CB7EC8E5B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8E81A-409C-41F1-9720-F32CE99B2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68324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F0A24-8514-4CF0-A281-358CB7EC8E5B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8E81A-409C-41F1-9720-F32CE99B2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8643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F0A24-8514-4CF0-A281-358CB7EC8E5B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8E81A-409C-41F1-9720-F32CE99B2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57617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F0A24-8514-4CF0-A281-358CB7EC8E5B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8E81A-409C-41F1-9720-F32CE99B2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3315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CF0A24-8514-4CF0-A281-358CB7EC8E5B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08E81A-409C-41F1-9720-F32CE99B2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096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5"/>
          <p:cNvSpPr txBox="1">
            <a:spLocks/>
          </p:cNvSpPr>
          <p:nvPr/>
        </p:nvSpPr>
        <p:spPr>
          <a:xfrm>
            <a:off x="457200" y="274638"/>
            <a:ext cx="8229600" cy="510657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200" dirty="0"/>
              <a:t>S2 Table. Top Metabolites Changed by Englerin Treatment for 48 h</a:t>
            </a: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34420031"/>
              </p:ext>
            </p:extLst>
          </p:nvPr>
        </p:nvGraphicFramePr>
        <p:xfrm>
          <a:off x="300518" y="785295"/>
          <a:ext cx="8559927" cy="5981829"/>
        </p:xfrm>
        <a:graphic>
          <a:graphicData uri="http://schemas.openxmlformats.org/drawingml/2006/table">
            <a:tbl>
              <a:tblPr/>
              <a:tblGrid>
                <a:gridCol w="243323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31539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9543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71586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3241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hemical Name</a:t>
                      </a:r>
                    </a:p>
                  </a:txBody>
                  <a:tcPr marL="8385" marR="8385" marT="838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thway Name</a:t>
                      </a:r>
                    </a:p>
                  </a:txBody>
                  <a:tcPr marL="8385" marR="8385" marT="838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VIP Score</a:t>
                      </a:r>
                    </a:p>
                  </a:txBody>
                  <a:tcPr marL="8385" marR="8385" marT="838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8hr-Englerin/ 48hr-Control</a:t>
                      </a:r>
                    </a:p>
                  </a:txBody>
                  <a:tcPr marL="8385" marR="8385" marT="838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ctadecanoylcarnitine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atty Acid Oxidation and Synthesis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139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.51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leoylcarnitine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atty Acid Oxidation and Synthesis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755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.03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-Hydroxyoleoylcarnitine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atty Acid Oxidation and Synthesis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413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59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-Hydroxyhexadecenoylcarnitine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atty Acid Oxidation and Synthesis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85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41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inoleylcarnitine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atty Acid Oxidation and Synthesis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081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70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-Hexadecenoylcarnitine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atty Acid Oxidation and Synthesis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079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69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S(18:0/20:4(8Z,11Z,14Z,17Z))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hospholipid Metabolism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86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23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-Palmitoylcarnitine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atty Acid Oxidation and Synthesis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45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04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ytidine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yrimidine Metabolism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61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65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C(20:4/P-16:0)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hospholipid Metabolism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75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28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-cystine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AM, SAH, Methionine, Cysteine, Glutathione Metabolism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27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09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S-hydroxyoctadecadienoic acid 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icosanoid and 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esolvin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Metabolism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10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02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arbamoylphosphate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yrimidine Metabolism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57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81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C(18:1/16:0)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anglioside Metabolism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591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56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C(18:1/20:0)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anglioside Metabolism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496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23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yristoylcarnitine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atty Acid Oxidation and Synthesis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02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59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yristoylcarnitine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atty Acid Oxidation and Synthesis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02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59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yristoylcarnitine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atty Acid Oxidation and Synthesis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42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42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yristoylcarnitine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atty Acid Oxidation and Synthesis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42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42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-Hydroxy-cis-5-tetradecenoylcarnitine 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atty Acid Oxidation and Synthesis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02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59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ICAR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urine Metabolism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37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40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C(18:1/24:1)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anglioside Metabolism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19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35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-hydroxyphenyllactic acid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icrobiome Metabolism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59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91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poxanthine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urine Metabolism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48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88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C(20:5/P-16:0)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hospholipid Metabolism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86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49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educed Glutathione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AM, SAH, Methionine, Cysteine, Glutathione Metabolism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11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0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ecanoylcarnitine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atty Acid Oxidation and Synthesis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09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1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ytidine triphosphate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yrimidine Metabolism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85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26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ndole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icrobiome Metabolism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50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9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-Aminoisobutyric acid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yrimidine Metabolism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23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3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odecanoylcarnitine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atty Acid Oxidation and Synthesis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04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09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lycerophosphocholine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hospholipid Metabolism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32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5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C(16:0/20:4)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hospholipid Metabolism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41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8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1664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hymidine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yrimidine Metabolism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12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2</a:t>
                      </a:r>
                    </a:p>
                  </a:txBody>
                  <a:tcPr marL="8385" marR="8385" marT="83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944351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263</Words>
  <Application>Microsoft Office PowerPoint</Application>
  <PresentationFormat>On-screen Show (4:3)</PresentationFormat>
  <Paragraphs>14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CSD Pediatric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tova, Ayse</dc:creator>
  <cp:lastModifiedBy>James Zapf</cp:lastModifiedBy>
  <cp:revision>7</cp:revision>
  <dcterms:created xsi:type="dcterms:W3CDTF">2016-08-03T02:33:50Z</dcterms:created>
  <dcterms:modified xsi:type="dcterms:W3CDTF">2017-02-27T21:56:44Z</dcterms:modified>
</cp:coreProperties>
</file>